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147374742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1512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gard,Dr.,Bobby (DR CI+IM) BIP-US-R" userId="8fb42a27-e12b-430d-ab3b-20c232fde4c7" providerId="ADAL" clId="{F9BE820C-2642-4673-8A5F-9FB6F5A00E1F}"/>
    <pc:docChg chg="delSld">
      <pc:chgData name="Norgard,Dr.,Bobby (DR CI+IM) BIP-US-R" userId="8fb42a27-e12b-430d-ab3b-20c232fde4c7" providerId="ADAL" clId="{F9BE820C-2642-4673-8A5F-9FB6F5A00E1F}" dt="2024-05-02T15:21:46.364" v="0" actId="47"/>
      <pc:docMkLst>
        <pc:docMk/>
      </pc:docMkLst>
      <pc:sldChg chg="del">
        <pc:chgData name="Norgard,Dr.,Bobby (DR CI+IM) BIP-US-R" userId="8fb42a27-e12b-430d-ab3b-20c232fde4c7" providerId="ADAL" clId="{F9BE820C-2642-4673-8A5F-9FB6F5A00E1F}" dt="2024-05-02T15:21:46.364" v="0" actId="47"/>
        <pc:sldMkLst>
          <pc:docMk/>
          <pc:sldMk cId="408838272" sldId="2147374672"/>
        </pc:sldMkLst>
      </pc:sldChg>
      <pc:sldChg chg="del">
        <pc:chgData name="Norgard,Dr.,Bobby (DR CI+IM) BIP-US-R" userId="8fb42a27-e12b-430d-ab3b-20c232fde4c7" providerId="ADAL" clId="{F9BE820C-2642-4673-8A5F-9FB6F5A00E1F}" dt="2024-05-02T15:21:46.364" v="0" actId="47"/>
        <pc:sldMkLst>
          <pc:docMk/>
          <pc:sldMk cId="3710560620" sldId="2147374714"/>
        </pc:sldMkLst>
      </pc:sldChg>
      <pc:sldChg chg="del">
        <pc:chgData name="Norgard,Dr.,Bobby (DR CI+IM) BIP-US-R" userId="8fb42a27-e12b-430d-ab3b-20c232fde4c7" providerId="ADAL" clId="{F9BE820C-2642-4673-8A5F-9FB6F5A00E1F}" dt="2024-05-02T15:21:46.364" v="0" actId="47"/>
        <pc:sldMkLst>
          <pc:docMk/>
          <pc:sldMk cId="457411378" sldId="2147374715"/>
        </pc:sldMkLst>
      </pc:sldChg>
      <pc:sldChg chg="del">
        <pc:chgData name="Norgard,Dr.,Bobby (DR CI+IM) BIP-US-R" userId="8fb42a27-e12b-430d-ab3b-20c232fde4c7" providerId="ADAL" clId="{F9BE820C-2642-4673-8A5F-9FB6F5A00E1F}" dt="2024-05-02T15:21:46.364" v="0" actId="47"/>
        <pc:sldMkLst>
          <pc:docMk/>
          <pc:sldMk cId="1104710727" sldId="2147374723"/>
        </pc:sldMkLst>
      </pc:sldChg>
      <pc:sldChg chg="del">
        <pc:chgData name="Norgard,Dr.,Bobby (DR CI+IM) BIP-US-R" userId="8fb42a27-e12b-430d-ab3b-20c232fde4c7" providerId="ADAL" clId="{F9BE820C-2642-4673-8A5F-9FB6F5A00E1F}" dt="2024-05-02T15:21:46.364" v="0" actId="47"/>
        <pc:sldMkLst>
          <pc:docMk/>
          <pc:sldMk cId="2434237610" sldId="2147374739"/>
        </pc:sldMkLst>
      </pc:sldChg>
      <pc:sldChg chg="del">
        <pc:chgData name="Norgard,Dr.,Bobby (DR CI+IM) BIP-US-R" userId="8fb42a27-e12b-430d-ab3b-20c232fde4c7" providerId="ADAL" clId="{F9BE820C-2642-4673-8A5F-9FB6F5A00E1F}" dt="2024-05-02T15:21:46.364" v="0" actId="47"/>
        <pc:sldMkLst>
          <pc:docMk/>
          <pc:sldMk cId="529728937" sldId="2147374740"/>
        </pc:sldMkLst>
      </pc:sldChg>
      <pc:sldChg chg="del">
        <pc:chgData name="Norgard,Dr.,Bobby (DR CI+IM) BIP-US-R" userId="8fb42a27-e12b-430d-ab3b-20c232fde4c7" providerId="ADAL" clId="{F9BE820C-2642-4673-8A5F-9FB6F5A00E1F}" dt="2024-05-02T15:21:46.364" v="0" actId="47"/>
        <pc:sldMkLst>
          <pc:docMk/>
          <pc:sldMk cId="1380050138" sldId="2147374741"/>
        </pc:sldMkLst>
      </pc:sldChg>
      <pc:sldChg chg="del">
        <pc:chgData name="Norgard,Dr.,Bobby (DR CI+IM) BIP-US-R" userId="8fb42a27-e12b-430d-ab3b-20c232fde4c7" providerId="ADAL" clId="{F9BE820C-2642-4673-8A5F-9FB6F5A00E1F}" dt="2024-05-02T15:21:46.364" v="0" actId="47"/>
        <pc:sldMkLst>
          <pc:docMk/>
          <pc:sldMk cId="1015601671" sldId="214737474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B95551-484D-43A4-B9A5-B2D7F224AFCA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21CA44-8096-4E9E-B465-288E5699C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1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19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34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921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-al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874-C1A9-453A-A6DE-ABB2EB5A8140}" type="datetime1">
              <a:rPr lang="en-GB" noProof="0" smtClean="0"/>
              <a:t>02/05/2024</a:t>
            </a:fld>
            <a:endParaRPr lang="en-GB" noProof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noProof="0"/>
              <a:t>Periostin In Vivo Planning_KPCY Monotherapy/PK Study</a:t>
            </a:r>
            <a:endParaRPr lang="en-GB" noProof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‹#›</a:t>
            </a:fld>
            <a:endParaRPr lang="en-GB" noProof="0"/>
          </a:p>
        </p:txBody>
      </p:sp>
      <p:cxnSp>
        <p:nvCxnSpPr>
          <p:cNvPr id="7" name="Gerade Verbindung 6"/>
          <p:cNvCxnSpPr/>
          <p:nvPr userDrawn="1"/>
        </p:nvCxnSpPr>
        <p:spPr>
          <a:xfrm>
            <a:off x="0" y="1295271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8647345"/>
            <a:ext cx="472703" cy="338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17759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642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4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18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67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18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97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0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3A8DACB-CB83-B5BB-8AEC-4B435BA50F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6542070"/>
              </p:ext>
            </p:extLst>
          </p:nvPr>
        </p:nvGraphicFramePr>
        <p:xfrm>
          <a:off x="1620966" y="1396194"/>
          <a:ext cx="3616069" cy="508689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27602">
                  <a:extLst>
                    <a:ext uri="{9D8B030D-6E8A-4147-A177-3AD203B41FA5}">
                      <a16:colId xmlns:a16="http://schemas.microsoft.com/office/drawing/2014/main" val="129889157"/>
                    </a:ext>
                  </a:extLst>
                </a:gridCol>
                <a:gridCol w="951597">
                  <a:extLst>
                    <a:ext uri="{9D8B030D-6E8A-4147-A177-3AD203B41FA5}">
                      <a16:colId xmlns:a16="http://schemas.microsoft.com/office/drawing/2014/main" val="868552095"/>
                    </a:ext>
                  </a:extLst>
                </a:gridCol>
                <a:gridCol w="936870">
                  <a:extLst>
                    <a:ext uri="{9D8B030D-6E8A-4147-A177-3AD203B41FA5}">
                      <a16:colId xmlns:a16="http://schemas.microsoft.com/office/drawing/2014/main" val="75635261"/>
                    </a:ext>
                  </a:extLst>
                </a:gridCol>
              </a:tblGrid>
              <a:tr h="10882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chemeClr val="tx1"/>
                          </a:solidFill>
                          <a:effectLst/>
                        </a:rPr>
                        <a:t>REAGENT or RESOURCE</a:t>
                      </a:r>
                      <a:endParaRPr lang="en-US" sz="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chemeClr val="tx1"/>
                          </a:solidFill>
                          <a:effectLst/>
                        </a:rPr>
                        <a:t>SOURCE</a:t>
                      </a:r>
                      <a:endParaRPr lang="en-US" sz="6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chemeClr val="tx1"/>
                          </a:solidFill>
                          <a:effectLst/>
                        </a:rPr>
                        <a:t>IDENTIFIER</a:t>
                      </a:r>
                      <a:endParaRPr lang="en-US" sz="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889925047"/>
                  </a:ext>
                </a:extLst>
              </a:tr>
              <a:tr h="97864">
                <a:tc gridSpan="3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chemeClr val="tx1"/>
                          </a:solidFill>
                          <a:effectLst/>
                        </a:rPr>
                        <a:t>Flow Cytometry Reagents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6858812"/>
                  </a:ext>
                </a:extLst>
              </a:tr>
              <a:tr h="1306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 err="1">
                          <a:effectLst/>
                        </a:rPr>
                        <a:t>TruStain</a:t>
                      </a:r>
                      <a:r>
                        <a:rPr lang="en-US" sz="600" dirty="0">
                          <a:effectLst/>
                        </a:rPr>
                        <a:t> </a:t>
                      </a:r>
                      <a:r>
                        <a:rPr lang="en-US" sz="600" dirty="0" err="1">
                          <a:effectLst/>
                        </a:rPr>
                        <a:t>FcX</a:t>
                      </a:r>
                      <a:r>
                        <a:rPr lang="en-US" sz="600" dirty="0">
                          <a:effectLst/>
                        </a:rPr>
                        <a:t> (anti-mouse CD16/32) Antibody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ioLegend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1320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128254242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Zombie Yellow Fixable Viability Kit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ioLegend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423104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755022146"/>
                  </a:ext>
                </a:extLst>
              </a:tr>
              <a:tr h="12596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ountBright Absolute Counting Bead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ThermoFisher Scientific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36950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587676836"/>
                  </a:ext>
                </a:extLst>
              </a:tr>
              <a:tr h="1273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 err="1">
                          <a:effectLst/>
                        </a:rPr>
                        <a:t>CellTrace</a:t>
                      </a:r>
                      <a:r>
                        <a:rPr lang="en-US" sz="600" dirty="0">
                          <a:effectLst/>
                        </a:rPr>
                        <a:t> Violet Cell Proliferation Kit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ThermoFisher Scientific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34557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244490941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Cell Staining Buffer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ioLegend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420201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826845310"/>
                  </a:ext>
                </a:extLst>
              </a:tr>
              <a:tr h="10999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Foxp3 / Transcription Factor Staining Buffer Set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 err="1">
                          <a:effectLst/>
                        </a:rPr>
                        <a:t>eBioscience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00-5523-00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344934948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UV395 CD45(30-F11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BD 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564279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2439911681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UV737 CD8a(53-6.7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D 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564297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2411951336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erCP/Cyanine5.5 CD4(GK1.5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ioLegend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0434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470736475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V510 TER-119(TER-119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D 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563995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295675335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V510 CD11b(M1/70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ioLegend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1263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70312523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V510 NK1.1(PK136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ioLegend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8738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4011936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V711 TCRb(H57-597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ioLegend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9243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598309445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V711 CD3(17A2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ioLegend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0241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39907400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PC-Cy7 CD45.1(A20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ioLegend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10716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1426627932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E/Dazzle 594 CD45.2(104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ioLegend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109846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195998995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540315230"/>
                  </a:ext>
                </a:extLst>
              </a:tr>
              <a:tr h="97864">
                <a:tc gridSpan="3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chemeClr val="tx1"/>
                          </a:solidFill>
                          <a:effectLst/>
                        </a:rPr>
                        <a:t>Critical commercial assays</a:t>
                      </a:r>
                      <a:endParaRPr lang="en-US" sz="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9335743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Next GEM Single Cell 3' GEM Kit v3.1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10x Genomics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00123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4192402260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Next GEM Single Cell 3' Gel Bead Kit v3.1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x Genomic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00122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2628037126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ingle Cell 3' v3.1 Gel Bead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x Genomic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2000164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683672277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hromium Next GEM Chip G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x Genomic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2000177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2665603104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Dual Index Plate TT Set A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x Genomic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3000431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1875131787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Library Construction Kit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600">
                          <a:effectLst/>
                        </a:rPr>
                        <a:t>10x Genomic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00190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1401536282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KAPA Library Quant Kit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Roche/KAPA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KK4873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1193233851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PRIselect Reagent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eckman Coulter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23318	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2444582938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High Sensitivity D5000 Tapestation Cassette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gilent Technologie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5067-5592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4199939351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High Sensitivity D5000 Tapestation Buffer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gilent Technologie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5190-7745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693162378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High Sensitivity D5000 Tapestation Ladder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gilent Technologie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5190-7747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385408473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600" dirty="0">
                          <a:effectLst/>
                        </a:rPr>
                        <a:t>KAPA SYBR FAST qPCR Master Mix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600">
                          <a:effectLst/>
                        </a:rPr>
                        <a:t>Illumina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KK4600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extLst>
                  <a:ext uri="{0D108BD9-81ED-4DB2-BD59-A6C34878D82A}">
                    <a16:rowId xmlns:a16="http://schemas.microsoft.com/office/drawing/2014/main" val="2162523148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1130031651"/>
                  </a:ext>
                </a:extLst>
              </a:tr>
              <a:tr h="101379">
                <a:tc gridSpan="3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chemeClr val="tx1"/>
                          </a:solidFill>
                          <a:effectLst/>
                        </a:rPr>
                        <a:t>IHC antibodies</a:t>
                      </a:r>
                    </a:p>
                  </a:txBody>
                  <a:tcPr marL="40808" marR="40808" marT="0" marB="0"/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 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 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1391924235"/>
                  </a:ext>
                </a:extLst>
              </a:tr>
              <a:tr h="13529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D8α XP Rabbit mAB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ell Signaling Technology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98941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1716393067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641361291"/>
                  </a:ext>
                </a:extLst>
              </a:tr>
              <a:tr h="97864">
                <a:tc gridSpan="3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chemeClr val="tx1"/>
                          </a:solidFill>
                          <a:effectLst/>
                        </a:rPr>
                        <a:t>Chemicals, peptides, and recombinant proteins</a:t>
                      </a:r>
                      <a:endParaRPr lang="en-US" sz="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3612779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DNase I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Roche/Sigma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104159001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1213519719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Dispase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Gibco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7105-041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517646663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ollagenase P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Roche/Sigma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1249002001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978381410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Tris-HCl (pH 7.4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igma Aldrich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T2194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extLst>
                  <a:ext uri="{0D108BD9-81ED-4DB2-BD59-A6C34878D82A}">
                    <a16:rowId xmlns:a16="http://schemas.microsoft.com/office/drawing/2014/main" val="991620901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odium Chloride (NaCl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igma Aldrich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5150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795196219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agnesium Chloride (MgCl</a:t>
                      </a:r>
                      <a:r>
                        <a:rPr lang="en-US" sz="600" baseline="-25000">
                          <a:effectLst/>
                        </a:rPr>
                        <a:t>2</a:t>
                      </a:r>
                      <a:r>
                        <a:rPr lang="en-US" sz="600">
                          <a:effectLst/>
                        </a:rPr>
                        <a:t>)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igma Aldrich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1028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3205278002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% BSA in DPBS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igma Aldrich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1595-50ML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extLst>
                  <a:ext uri="{0D108BD9-81ED-4DB2-BD59-A6C34878D82A}">
                    <a16:rowId xmlns:a16="http://schemas.microsoft.com/office/drawing/2014/main" val="3943269387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Low TE Buffer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Thermo Fisher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2090-015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extLst>
                  <a:ext uri="{0D108BD9-81ED-4DB2-BD59-A6C34878D82A}">
                    <a16:rowId xmlns:a16="http://schemas.microsoft.com/office/drawing/2014/main" val="3259530734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Tris 1M pH 7.0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illipore Sigma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T1819-100ML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553172913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600" dirty="0">
                          <a:effectLst/>
                        </a:rPr>
                        <a:t>10% Tween 20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600">
                          <a:effectLst/>
                        </a:rPr>
                        <a:t>Bio-Rad 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600" dirty="0">
                          <a:effectLst/>
                        </a:rPr>
                        <a:t>1662404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extLst>
                  <a:ext uri="{0D108BD9-81ED-4DB2-BD59-A6C34878D82A}">
                    <a16:rowId xmlns:a16="http://schemas.microsoft.com/office/drawing/2014/main" val="3424458736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uffer EB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Qiagen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014608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/>
                </a:tc>
                <a:extLst>
                  <a:ext uri="{0D108BD9-81ED-4DB2-BD59-A6C34878D82A}">
                    <a16:rowId xmlns:a16="http://schemas.microsoft.com/office/drawing/2014/main" val="207426321"/>
                  </a:ext>
                </a:extLst>
              </a:tr>
              <a:tr h="101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ViaStain AOPI Staining Solution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Nexcelom</a:t>
                      </a:r>
                      <a:endParaRPr lang="en-US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CS2-0106-5mL</a:t>
                      </a:r>
                      <a:endParaRPr lang="en-US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08" marR="40808" marT="0" marB="0" anchor="ctr"/>
                </a:tc>
                <a:extLst>
                  <a:ext uri="{0D108BD9-81ED-4DB2-BD59-A6C34878D82A}">
                    <a16:rowId xmlns:a16="http://schemas.microsoft.com/office/drawing/2014/main" val="984950424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63810ABD-BCF7-95C6-7636-3664C216B2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0394" y="794928"/>
            <a:ext cx="1757212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228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228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228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228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228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228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228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228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228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28600" algn="l"/>
              </a:tabLst>
            </a:pP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EY RESOURCES TABLE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" name="Title 2">
            <a:extLst>
              <a:ext uri="{FF2B5EF4-FFF2-40B4-BE49-F238E27FC236}">
                <a16:creationId xmlns:a16="http://schemas.microsoft.com/office/drawing/2014/main" id="{791D8ACA-52D8-28EE-14A3-FB52AF817B32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657975" cy="3079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</a:p>
        </p:txBody>
      </p:sp>
    </p:spTree>
    <p:extLst>
      <p:ext uri="{BB962C8B-B14F-4D97-AF65-F5344CB8AC3E}">
        <p14:creationId xmlns:p14="http://schemas.microsoft.com/office/powerpoint/2010/main" val="2257143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451DDB2A9AB341B622F9036981046A" ma:contentTypeVersion="17" ma:contentTypeDescription="Create a new document." ma:contentTypeScope="" ma:versionID="44c2e872cbac6b246f5d634d493eb487">
  <xsd:schema xmlns:xsd="http://www.w3.org/2001/XMLSchema" xmlns:xs="http://www.w3.org/2001/XMLSchema" xmlns:p="http://schemas.microsoft.com/office/2006/metadata/properties" xmlns:ns2="9acdd090-06b3-455d-ab64-99cb7fe7470c" xmlns:ns3="926762ed-9515-4d6a-a527-d28b70bf3669" xmlns:ns4="e47812bf-c8f0-415c-9dc6-756594725798" targetNamespace="http://schemas.microsoft.com/office/2006/metadata/properties" ma:root="true" ma:fieldsID="eb05650a2fac9d65bfaa2aafe88c574a" ns2:_="" ns3:_="" ns4:_="">
    <xsd:import namespace="9acdd090-06b3-455d-ab64-99cb7fe7470c"/>
    <xsd:import namespace="926762ed-9515-4d6a-a527-d28b70bf3669"/>
    <xsd:import namespace="e47812bf-c8f0-415c-9dc6-75659472579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4:TaxCatchAll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cdd090-06b3-455d-ab64-99cb7fe7470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798f3110-b2b7-48bc-b5f0-a137367be0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6762ed-9515-4d6a-a527-d28b70bf366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7812bf-c8f0-415c-9dc6-756594725798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178fb918-bae2-4388-ae3c-9857c311f631}" ma:internalName="TaxCatchAll" ma:showField="CatchAllData" ma:web="926762ed-9515-4d6a-a527-d28b70bf366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acdd090-06b3-455d-ab64-99cb7fe7470c">
      <Terms xmlns="http://schemas.microsoft.com/office/infopath/2007/PartnerControls"/>
    </lcf76f155ced4ddcb4097134ff3c332f>
    <TaxCatchAll xmlns="e47812bf-c8f0-415c-9dc6-756594725798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119F5F3-63F0-455D-B14B-B78AB0E631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acdd090-06b3-455d-ab64-99cb7fe7470c"/>
    <ds:schemaRef ds:uri="926762ed-9515-4d6a-a527-d28b70bf3669"/>
    <ds:schemaRef ds:uri="e47812bf-c8f0-415c-9dc6-75659472579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8CBD9CD-A4AA-415E-872A-4904A09AF53E}">
  <ds:schemaRefs>
    <ds:schemaRef ds:uri="http://purl.org/dc/elements/1.1/"/>
    <ds:schemaRef ds:uri="http://schemas.microsoft.com/office/infopath/2007/PartnerControls"/>
    <ds:schemaRef ds:uri="http://purl.org/dc/terms/"/>
    <ds:schemaRef ds:uri="http://schemas.microsoft.com/office/2006/metadata/properties"/>
    <ds:schemaRef ds:uri="9acdd090-06b3-455d-ab64-99cb7fe7470c"/>
    <ds:schemaRef ds:uri="http://schemas.microsoft.com/office/2006/documentManagement/types"/>
    <ds:schemaRef ds:uri="http://schemas.openxmlformats.org/package/2006/metadata/core-properties"/>
    <ds:schemaRef ds:uri="e47812bf-c8f0-415c-9dc6-756594725798"/>
    <ds:schemaRef ds:uri="926762ed-9515-4d6a-a527-d28b70bf3669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0ED1A073-550F-498F-B90D-40453BF36B9D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e1f8af86-ee95-4718-bd0d-375b37366c83}" enabled="0" method="" siteId="{e1f8af86-ee95-4718-bd0d-375b37366c8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</TotalTime>
  <Words>331</Words>
  <Application>Microsoft Office PowerPoint</Application>
  <PresentationFormat>Letter Paper (8.5x11 in)</PresentationFormat>
  <Paragraphs>1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Dr.,Sarah (RES CI+IM) BIP-US-R</dc:creator>
  <cp:lastModifiedBy>Norgard,Dr.,Bobby (DR CI+IM) BIP-US-R</cp:lastModifiedBy>
  <cp:revision>6</cp:revision>
  <dcterms:created xsi:type="dcterms:W3CDTF">2024-01-18T14:22:02Z</dcterms:created>
  <dcterms:modified xsi:type="dcterms:W3CDTF">2024-05-02T15:21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451DDB2A9AB341B622F9036981046A</vt:lpwstr>
  </property>
  <property fmtid="{D5CDD505-2E9C-101B-9397-08002B2CF9AE}" pid="3" name="MediaServiceImageTags">
    <vt:lpwstr/>
  </property>
</Properties>
</file>